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12" r:id="rId2"/>
  </p:sldIdLst>
  <p:sldSz cx="12192000" cy="6858000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99"/>
    <a:srgbClr val="9900FF"/>
    <a:srgbClr val="477BA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8FD4443E-F989-4FC4-A0C8-D5A2AF1F390B}" styleName="濃色スタイル 1 - アクセント 5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wholeTbl>
    <a:band1H>
      <a:tcStyle>
        <a:tcBdr/>
        <a:fill>
          <a:solidFill>
            <a:schemeClr val="accent5">
              <a:shade val="60000"/>
            </a:schemeClr>
          </a:solidFill>
        </a:fill>
      </a:tcStyle>
    </a:band1H>
    <a:band1V>
      <a:tcStyle>
        <a:tcBdr/>
        <a:fill>
          <a:solidFill>
            <a:schemeClr val="accent5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5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5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5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69CF1AB2-1976-4502-BF36-3FF5EA218861}" styleName="中間スタイル 4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35758FB7-9AC5-4552-8A53-C91805E547FA}" styleName="テーマ スタイル 1 - アクセント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  <a:tblStyle styleId="{125E5076-3810-47DD-B79F-674D7AD40C01}" styleName="濃色スタイル 1 - アクセント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7DF18680-E054-41AD-8BC1-D1AEF772440D}" styleName="中間スタイル 2 - アクセント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306799F8-075E-4A3A-A7F6-7FBC6576F1A4}" styleName="テーマ スタイル 2 - アクセント 3">
    <a:tblBg>
      <a:fillRef idx="3">
        <a:schemeClr val="accent3"/>
      </a:fillRef>
      <a:effectRef idx="3">
        <a:schemeClr val="accent3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3">
                <a:tint val="50000"/>
              </a:schemeClr>
            </a:lnRef>
          </a:left>
          <a:right>
            <a:lnRef idx="1">
              <a:schemeClr val="accent3">
                <a:tint val="50000"/>
              </a:schemeClr>
            </a:lnRef>
          </a:right>
          <a:top>
            <a:lnRef idx="1">
              <a:schemeClr val="accent3">
                <a:tint val="50000"/>
              </a:schemeClr>
            </a:lnRef>
          </a:top>
          <a:bottom>
            <a:lnRef idx="1">
              <a:schemeClr val="accent3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607" autoAdjust="0"/>
    <p:restoredTop sz="92972" autoAdjust="0"/>
  </p:normalViewPr>
  <p:slideViewPr>
    <p:cSldViewPr snapToGrid="0">
      <p:cViewPr varScale="1">
        <p:scale>
          <a:sx n="107" d="100"/>
          <a:sy n="107" d="100"/>
        </p:scale>
        <p:origin x="1062" y="108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Users\admin\Desktop\DOAC&#36969;&#27491;&#29992;&#37327;&#35542;&#25991;\&#12487;&#12540;&#12479;\DOAC&#20302;&#29992;&#37327;JMP&#35299;&#26512;&#12487;&#12540;&#12479;&#12505;&#12540;&#12473;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適正性 医師'!$B$10</c:f>
              <c:strCache>
                <c:ptCount val="1"/>
                <c:pt idx="0">
                  <c:v>Appropriate standard dose</c:v>
                </c:pt>
              </c:strCache>
            </c:strRef>
          </c:tx>
          <c:spPr>
            <a:pattFill prst="pct75">
              <a:fgClr>
                <a:schemeClr val="tx1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適正性 医師'!$C$9:$N$9</c:f>
              <c:strCache>
                <c:ptCount val="12"/>
                <c:pt idx="0">
                  <c:v>A (n=50)</c:v>
                </c:pt>
                <c:pt idx="1">
                  <c:v>B (n=38)</c:v>
                </c:pt>
                <c:pt idx="2">
                  <c:v>C (n=29)</c:v>
                </c:pt>
                <c:pt idx="3">
                  <c:v>D (n=26)</c:v>
                </c:pt>
                <c:pt idx="4">
                  <c:v>E (n=22)</c:v>
                </c:pt>
                <c:pt idx="5">
                  <c:v>F (n=21)</c:v>
                </c:pt>
                <c:pt idx="6">
                  <c:v>G (n=17)</c:v>
                </c:pt>
                <c:pt idx="7">
                  <c:v>H (n=14)</c:v>
                </c:pt>
                <c:pt idx="8">
                  <c:v>I (n=13)</c:v>
                </c:pt>
                <c:pt idx="9">
                  <c:v>J (n=12)</c:v>
                </c:pt>
                <c:pt idx="10">
                  <c:v>K (n=12)</c:v>
                </c:pt>
                <c:pt idx="11">
                  <c:v>L (n=11)</c:v>
                </c:pt>
              </c:strCache>
            </c:strRef>
          </c:cat>
          <c:val>
            <c:numRef>
              <c:f>'適正性 医師'!$C$10:$N$10</c:f>
              <c:numCache>
                <c:formatCode>0.0</c:formatCode>
                <c:ptCount val="12"/>
                <c:pt idx="0">
                  <c:v>50</c:v>
                </c:pt>
                <c:pt idx="1">
                  <c:v>36.84210526315789</c:v>
                </c:pt>
                <c:pt idx="2">
                  <c:v>44.827586206896555</c:v>
                </c:pt>
                <c:pt idx="3">
                  <c:v>46.153846153846153</c:v>
                </c:pt>
                <c:pt idx="4">
                  <c:v>31.818181818181817</c:v>
                </c:pt>
                <c:pt idx="5">
                  <c:v>42.857142857142854</c:v>
                </c:pt>
                <c:pt idx="6">
                  <c:v>29.411764705882355</c:v>
                </c:pt>
                <c:pt idx="7">
                  <c:v>21.428571428571427</c:v>
                </c:pt>
                <c:pt idx="8">
                  <c:v>38.461538461538467</c:v>
                </c:pt>
                <c:pt idx="9">
                  <c:v>25</c:v>
                </c:pt>
                <c:pt idx="10">
                  <c:v>33.333333333333329</c:v>
                </c:pt>
                <c:pt idx="11">
                  <c:v>18.1818181818181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71B-4FE7-ADB0-1648C4FD6113}"/>
            </c:ext>
          </c:extLst>
        </c:ser>
        <c:ser>
          <c:idx val="1"/>
          <c:order val="1"/>
          <c:tx>
            <c:strRef>
              <c:f>'適正性 医師'!$B$11</c:f>
              <c:strCache>
                <c:ptCount val="1"/>
                <c:pt idx="0">
                  <c:v>Inappropriate standard dose (overdosing)</c:v>
                </c:pt>
              </c:strCache>
            </c:strRef>
          </c:tx>
          <c:spPr>
            <a:pattFill prst="dk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適正性 医師'!$C$9:$N$9</c:f>
              <c:strCache>
                <c:ptCount val="12"/>
                <c:pt idx="0">
                  <c:v>A (n=50)</c:v>
                </c:pt>
                <c:pt idx="1">
                  <c:v>B (n=38)</c:v>
                </c:pt>
                <c:pt idx="2">
                  <c:v>C (n=29)</c:v>
                </c:pt>
                <c:pt idx="3">
                  <c:v>D (n=26)</c:v>
                </c:pt>
                <c:pt idx="4">
                  <c:v>E (n=22)</c:v>
                </c:pt>
                <c:pt idx="5">
                  <c:v>F (n=21)</c:v>
                </c:pt>
                <c:pt idx="6">
                  <c:v>G (n=17)</c:v>
                </c:pt>
                <c:pt idx="7">
                  <c:v>H (n=14)</c:v>
                </c:pt>
                <c:pt idx="8">
                  <c:v>I (n=13)</c:v>
                </c:pt>
                <c:pt idx="9">
                  <c:v>J (n=12)</c:v>
                </c:pt>
                <c:pt idx="10">
                  <c:v>K (n=12)</c:v>
                </c:pt>
                <c:pt idx="11">
                  <c:v>L (n=11)</c:v>
                </c:pt>
              </c:strCache>
            </c:strRef>
          </c:cat>
          <c:val>
            <c:numRef>
              <c:f>'適正性 医師'!$C$11:$N$11</c:f>
              <c:numCache>
                <c:formatCode>0.0</c:formatCode>
                <c:ptCount val="12"/>
                <c:pt idx="0">
                  <c:v>4</c:v>
                </c:pt>
                <c:pt idx="1">
                  <c:v>5.2631578947368416</c:v>
                </c:pt>
                <c:pt idx="2">
                  <c:v>0</c:v>
                </c:pt>
                <c:pt idx="3">
                  <c:v>0</c:v>
                </c:pt>
                <c:pt idx="4">
                  <c:v>4.5454545454545459</c:v>
                </c:pt>
                <c:pt idx="5">
                  <c:v>9.5238095238095237</c:v>
                </c:pt>
                <c:pt idx="6">
                  <c:v>0</c:v>
                </c:pt>
                <c:pt idx="7">
                  <c:v>0</c:v>
                </c:pt>
                <c:pt idx="8">
                  <c:v>7.6923076923076925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71B-4FE7-ADB0-1648C4FD6113}"/>
            </c:ext>
          </c:extLst>
        </c:ser>
        <c:ser>
          <c:idx val="2"/>
          <c:order val="2"/>
          <c:tx>
            <c:strRef>
              <c:f>'適正性 医師'!$B$12</c:f>
              <c:strCache>
                <c:ptCount val="1"/>
                <c:pt idx="0">
                  <c:v>Appropriate reduced dose</c:v>
                </c:pt>
              </c:strCache>
            </c:strRef>
          </c:tx>
          <c:spPr>
            <a:pattFill prst="pct25">
              <a:fgClr>
                <a:schemeClr val="tx1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適正性 医師'!$C$9:$N$9</c:f>
              <c:strCache>
                <c:ptCount val="12"/>
                <c:pt idx="0">
                  <c:v>A (n=50)</c:v>
                </c:pt>
                <c:pt idx="1">
                  <c:v>B (n=38)</c:v>
                </c:pt>
                <c:pt idx="2">
                  <c:v>C (n=29)</c:v>
                </c:pt>
                <c:pt idx="3">
                  <c:v>D (n=26)</c:v>
                </c:pt>
                <c:pt idx="4">
                  <c:v>E (n=22)</c:v>
                </c:pt>
                <c:pt idx="5">
                  <c:v>F (n=21)</c:v>
                </c:pt>
                <c:pt idx="6">
                  <c:v>G (n=17)</c:v>
                </c:pt>
                <c:pt idx="7">
                  <c:v>H (n=14)</c:v>
                </c:pt>
                <c:pt idx="8">
                  <c:v>I (n=13)</c:v>
                </c:pt>
                <c:pt idx="9">
                  <c:v>J (n=12)</c:v>
                </c:pt>
                <c:pt idx="10">
                  <c:v>K (n=12)</c:v>
                </c:pt>
                <c:pt idx="11">
                  <c:v>L (n=11)</c:v>
                </c:pt>
              </c:strCache>
            </c:strRef>
          </c:cat>
          <c:val>
            <c:numRef>
              <c:f>'適正性 医師'!$C$12:$N$12</c:f>
              <c:numCache>
                <c:formatCode>0.0</c:formatCode>
                <c:ptCount val="12"/>
                <c:pt idx="0">
                  <c:v>38</c:v>
                </c:pt>
                <c:pt idx="1">
                  <c:v>31.578947368421051</c:v>
                </c:pt>
                <c:pt idx="2">
                  <c:v>41.379310344827587</c:v>
                </c:pt>
                <c:pt idx="3">
                  <c:v>30.76923076923077</c:v>
                </c:pt>
                <c:pt idx="4">
                  <c:v>50</c:v>
                </c:pt>
                <c:pt idx="5">
                  <c:v>47.619047619047613</c:v>
                </c:pt>
                <c:pt idx="6">
                  <c:v>41.17647058823529</c:v>
                </c:pt>
                <c:pt idx="7">
                  <c:v>35.714285714285715</c:v>
                </c:pt>
                <c:pt idx="8">
                  <c:v>53.846153846153847</c:v>
                </c:pt>
                <c:pt idx="9">
                  <c:v>41.666666666666671</c:v>
                </c:pt>
                <c:pt idx="10">
                  <c:v>50</c:v>
                </c:pt>
                <c:pt idx="11">
                  <c:v>36.3636363636363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71B-4FE7-ADB0-1648C4FD6113}"/>
            </c:ext>
          </c:extLst>
        </c:ser>
        <c:ser>
          <c:idx val="3"/>
          <c:order val="3"/>
          <c:tx>
            <c:strRef>
              <c:f>'適正性 医師'!$B$13</c:f>
              <c:strCache>
                <c:ptCount val="1"/>
                <c:pt idx="0">
                  <c:v>Inappropriate reduced dose (underdosing)</c:v>
                </c:pt>
              </c:strCache>
            </c:strRef>
          </c:tx>
          <c:spPr>
            <a:pattFill prst="dk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適正性 医師'!$C$9:$N$9</c:f>
              <c:strCache>
                <c:ptCount val="12"/>
                <c:pt idx="0">
                  <c:v>A (n=50)</c:v>
                </c:pt>
                <c:pt idx="1">
                  <c:v>B (n=38)</c:v>
                </c:pt>
                <c:pt idx="2">
                  <c:v>C (n=29)</c:v>
                </c:pt>
                <c:pt idx="3">
                  <c:v>D (n=26)</c:v>
                </c:pt>
                <c:pt idx="4">
                  <c:v>E (n=22)</c:v>
                </c:pt>
                <c:pt idx="5">
                  <c:v>F (n=21)</c:v>
                </c:pt>
                <c:pt idx="6">
                  <c:v>G (n=17)</c:v>
                </c:pt>
                <c:pt idx="7">
                  <c:v>H (n=14)</c:v>
                </c:pt>
                <c:pt idx="8">
                  <c:v>I (n=13)</c:v>
                </c:pt>
                <c:pt idx="9">
                  <c:v>J (n=12)</c:v>
                </c:pt>
                <c:pt idx="10">
                  <c:v>K (n=12)</c:v>
                </c:pt>
                <c:pt idx="11">
                  <c:v>L (n=11)</c:v>
                </c:pt>
              </c:strCache>
            </c:strRef>
          </c:cat>
          <c:val>
            <c:numRef>
              <c:f>'適正性 医師'!$C$13:$N$13</c:f>
              <c:numCache>
                <c:formatCode>0.0</c:formatCode>
                <c:ptCount val="12"/>
                <c:pt idx="0">
                  <c:v>8</c:v>
                </c:pt>
                <c:pt idx="1">
                  <c:v>26.315789473684209</c:v>
                </c:pt>
                <c:pt idx="2">
                  <c:v>13.793103448275861</c:v>
                </c:pt>
                <c:pt idx="3">
                  <c:v>23.076923076923077</c:v>
                </c:pt>
                <c:pt idx="4">
                  <c:v>13.636363636363635</c:v>
                </c:pt>
                <c:pt idx="5">
                  <c:v>0</c:v>
                </c:pt>
                <c:pt idx="6">
                  <c:v>29.411764705882355</c:v>
                </c:pt>
                <c:pt idx="7">
                  <c:v>42.857142857142854</c:v>
                </c:pt>
                <c:pt idx="8">
                  <c:v>0</c:v>
                </c:pt>
                <c:pt idx="9">
                  <c:v>33.333333333333329</c:v>
                </c:pt>
                <c:pt idx="10">
                  <c:v>16.666666666666664</c:v>
                </c:pt>
                <c:pt idx="11">
                  <c:v>45.4545454545454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71B-4FE7-ADB0-1648C4FD611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481664288"/>
        <c:axId val="1"/>
      </c:barChart>
      <c:catAx>
        <c:axId val="4816642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vert="horz"/>
          <a:lstStyle/>
          <a:p>
            <a:pPr>
              <a:defRPr sz="12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_);[Red]\(#,##0\)" sourceLinked="0"/>
        <c:majorTickMark val="none"/>
        <c:minorTickMark val="none"/>
        <c:tickLblPos val="nextTo"/>
        <c:spPr>
          <a:ln w="9525">
            <a:noFill/>
          </a:ln>
        </c:spPr>
        <c:txPr>
          <a:bodyPr rot="-60000000" vert="horz"/>
          <a:lstStyle/>
          <a:p>
            <a:pPr>
              <a:defRPr sz="12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481664288"/>
        <c:crosses val="autoZero"/>
        <c:crossBetween val="between"/>
      </c:valAx>
      <c:spPr>
        <a:noFill/>
        <a:ln w="25400">
          <a:noFill/>
        </a:ln>
      </c:spPr>
    </c:plotArea>
    <c:legend>
      <c:legendPos val="r"/>
      <c:layout/>
      <c:overlay val="0"/>
      <c:spPr>
        <a:noFill/>
        <a:ln w="25400">
          <a:noFill/>
        </a:ln>
      </c:spPr>
      <c:txPr>
        <a:bodyPr rot="0" vert="horz"/>
        <a:lstStyle/>
        <a:p>
          <a:pPr>
            <a:defRPr sz="1400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 sz="105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4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97A80A-39A4-430B-8FE1-0704398E50C8}" type="datetimeFigureOut">
              <a:rPr kumimoji="1" lang="ja-JP" altLang="en-US" smtClean="0"/>
              <a:t>2019/8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585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4" y="9428585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C23BB9A-1577-414D-BB69-94CB2568B5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134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AE848-DCC9-4E1C-87C6-57416F14FD38}" type="datetimeFigureOut">
              <a:rPr kumimoji="1" lang="ja-JP" altLang="en-US" smtClean="0"/>
              <a:t>2019/8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C02E0-1D69-4427-AE6E-6568B68D69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50178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AE848-DCC9-4E1C-87C6-57416F14FD38}" type="datetimeFigureOut">
              <a:rPr kumimoji="1" lang="ja-JP" altLang="en-US" smtClean="0"/>
              <a:t>2019/8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C02E0-1D69-4427-AE6E-6568B68D69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04186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AE848-DCC9-4E1C-87C6-57416F14FD38}" type="datetimeFigureOut">
              <a:rPr kumimoji="1" lang="ja-JP" altLang="en-US" smtClean="0"/>
              <a:t>2019/8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C02E0-1D69-4427-AE6E-6568B68D69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76702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AE848-DCC9-4E1C-87C6-57416F14FD38}" type="datetimeFigureOut">
              <a:rPr kumimoji="1" lang="ja-JP" altLang="en-US" smtClean="0"/>
              <a:t>2019/8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C02E0-1D69-4427-AE6E-6568B68D69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45750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AE848-DCC9-4E1C-87C6-57416F14FD38}" type="datetimeFigureOut">
              <a:rPr kumimoji="1" lang="ja-JP" altLang="en-US" smtClean="0"/>
              <a:t>2019/8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C02E0-1D69-4427-AE6E-6568B68D69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99756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AE848-DCC9-4E1C-87C6-57416F14FD38}" type="datetimeFigureOut">
              <a:rPr kumimoji="1" lang="ja-JP" altLang="en-US" smtClean="0"/>
              <a:t>2019/8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C02E0-1D69-4427-AE6E-6568B68D69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47236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AE848-DCC9-4E1C-87C6-57416F14FD38}" type="datetimeFigureOut">
              <a:rPr kumimoji="1" lang="ja-JP" altLang="en-US" smtClean="0"/>
              <a:t>2019/8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C02E0-1D69-4427-AE6E-6568B68D69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32341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AE848-DCC9-4E1C-87C6-57416F14FD38}" type="datetimeFigureOut">
              <a:rPr kumimoji="1" lang="ja-JP" altLang="en-US" smtClean="0"/>
              <a:t>2019/8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C02E0-1D69-4427-AE6E-6568B68D69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58597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AE848-DCC9-4E1C-87C6-57416F14FD38}" type="datetimeFigureOut">
              <a:rPr kumimoji="1" lang="ja-JP" altLang="en-US" smtClean="0"/>
              <a:t>2019/8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C02E0-1D69-4427-AE6E-6568B68D69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07613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AE848-DCC9-4E1C-87C6-57416F14FD38}" type="datetimeFigureOut">
              <a:rPr kumimoji="1" lang="ja-JP" altLang="en-US" smtClean="0"/>
              <a:t>2019/8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C02E0-1D69-4427-AE6E-6568B68D69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73228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AE848-DCC9-4E1C-87C6-57416F14FD38}" type="datetimeFigureOut">
              <a:rPr kumimoji="1" lang="ja-JP" altLang="en-US" smtClean="0"/>
              <a:t>2019/8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AC02E0-1D69-4427-AE6E-6568B68D69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39752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4AE848-DCC9-4E1C-87C6-57416F14FD38}" type="datetimeFigureOut">
              <a:rPr kumimoji="1" lang="ja-JP" altLang="en-US" smtClean="0"/>
              <a:t>2019/8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AC02E0-1D69-4427-AE6E-6568B68D69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21527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66537582"/>
              </p:ext>
            </p:extLst>
          </p:nvPr>
        </p:nvGraphicFramePr>
        <p:xfrm>
          <a:off x="2667000" y="1371600"/>
          <a:ext cx="6858000" cy="4114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タイトル 1">
            <a:extLst>
              <a:ext uri="{FF2B5EF4-FFF2-40B4-BE49-F238E27FC236}">
                <a16:creationId xmlns:a16="http://schemas.microsoft.com/office/drawing/2014/main" id="{65EB6828-9DCC-42FD-A564-1B41508F495F}"/>
              </a:ext>
            </a:extLst>
          </p:cNvPr>
          <p:cNvSpPr txBox="1">
            <a:spLocks/>
          </p:cNvSpPr>
          <p:nvPr/>
        </p:nvSpPr>
        <p:spPr>
          <a:xfrm>
            <a:off x="699075" y="77046"/>
            <a:ext cx="3671133" cy="480131"/>
          </a:xfrm>
          <a:prstGeom prst="rect">
            <a:avLst/>
          </a:prstGeom>
        </p:spPr>
        <p:txBody>
          <a:bodyPr vert="horz" wrap="none" lIns="91440" tIns="45720" rIns="91440" bIns="45720" rtlCol="0" anchor="ctr">
            <a:sp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800" b="1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Supplemental Figure </a:t>
            </a:r>
            <a:r>
              <a:rPr lang="en-US" altLang="ja-JP" sz="2800" b="1" dirty="0" smtClean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</a:t>
            </a:r>
            <a:endParaRPr lang="en-US" altLang="ja-JP" sz="2800" b="1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2662517" y="1099084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%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09112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760</TotalTime>
  <Words>4</Words>
  <Application>Microsoft Office PowerPoint</Application>
  <PresentationFormat>ワイド画面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ＭＳ Ｐゴシック</vt:lpstr>
      <vt:lpstr>メイリオ</vt:lpstr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直接作用型経口抗凝固薬（DOAC）の初回投与量の実態調査</dc:title>
  <dc:creator>宮崎元康</dc:creator>
  <cp:lastModifiedBy>admin</cp:lastModifiedBy>
  <cp:revision>328</cp:revision>
  <cp:lastPrinted>2019-08-09T09:09:11Z</cp:lastPrinted>
  <dcterms:created xsi:type="dcterms:W3CDTF">2018-02-23T13:38:19Z</dcterms:created>
  <dcterms:modified xsi:type="dcterms:W3CDTF">2019-08-09T09:09:13Z</dcterms:modified>
</cp:coreProperties>
</file>